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858000" cy="9906000" type="A4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95" autoAdjust="0"/>
    <p:restoredTop sz="94660"/>
  </p:normalViewPr>
  <p:slideViewPr>
    <p:cSldViewPr snapToGrid="0">
      <p:cViewPr>
        <p:scale>
          <a:sx n="130" d="100"/>
          <a:sy n="130" d="100"/>
        </p:scale>
        <p:origin x="320" y="-25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067EB-531C-4D1A-AD66-42236629F9B6}" type="datetimeFigureOut">
              <a:rPr lang="nl-BE" smtClean="0"/>
              <a:t>10/12/2018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3E0BE-4853-403E-9FA7-4C3BE85CD619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5831980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067EB-531C-4D1A-AD66-42236629F9B6}" type="datetimeFigureOut">
              <a:rPr lang="nl-BE" smtClean="0"/>
              <a:t>10/12/2018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3E0BE-4853-403E-9FA7-4C3BE85CD619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4319826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067EB-531C-4D1A-AD66-42236629F9B6}" type="datetimeFigureOut">
              <a:rPr lang="nl-BE" smtClean="0"/>
              <a:t>10/12/2018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3E0BE-4853-403E-9FA7-4C3BE85CD619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4274134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067EB-531C-4D1A-AD66-42236629F9B6}" type="datetimeFigureOut">
              <a:rPr lang="nl-BE" smtClean="0"/>
              <a:t>10/12/2018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3E0BE-4853-403E-9FA7-4C3BE85CD619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3325843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067EB-531C-4D1A-AD66-42236629F9B6}" type="datetimeFigureOut">
              <a:rPr lang="nl-BE" smtClean="0"/>
              <a:t>10/12/2018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3E0BE-4853-403E-9FA7-4C3BE85CD619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8946688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067EB-531C-4D1A-AD66-42236629F9B6}" type="datetimeFigureOut">
              <a:rPr lang="nl-BE" smtClean="0"/>
              <a:t>10/12/2018</a:t>
            </a:fld>
            <a:endParaRPr lang="nl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3E0BE-4853-403E-9FA7-4C3BE85CD619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2085495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067EB-531C-4D1A-AD66-42236629F9B6}" type="datetimeFigureOut">
              <a:rPr lang="nl-BE" smtClean="0"/>
              <a:t>10/12/2018</a:t>
            </a:fld>
            <a:endParaRPr lang="nl-B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3E0BE-4853-403E-9FA7-4C3BE85CD619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9953795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067EB-531C-4D1A-AD66-42236629F9B6}" type="datetimeFigureOut">
              <a:rPr lang="nl-BE" smtClean="0"/>
              <a:t>10/12/2018</a:t>
            </a:fld>
            <a:endParaRPr lang="nl-B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3E0BE-4853-403E-9FA7-4C3BE85CD619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220143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067EB-531C-4D1A-AD66-42236629F9B6}" type="datetimeFigureOut">
              <a:rPr lang="nl-BE" smtClean="0"/>
              <a:t>10/12/2018</a:t>
            </a:fld>
            <a:endParaRPr lang="nl-B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3E0BE-4853-403E-9FA7-4C3BE85CD619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9373069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067EB-531C-4D1A-AD66-42236629F9B6}" type="datetimeFigureOut">
              <a:rPr lang="nl-BE" smtClean="0"/>
              <a:t>10/12/2018</a:t>
            </a:fld>
            <a:endParaRPr lang="nl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3E0BE-4853-403E-9FA7-4C3BE85CD619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4499680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067EB-531C-4D1A-AD66-42236629F9B6}" type="datetimeFigureOut">
              <a:rPr lang="nl-BE" smtClean="0"/>
              <a:t>10/12/2018</a:t>
            </a:fld>
            <a:endParaRPr lang="nl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33E0BE-4853-403E-9FA7-4C3BE85CD619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8865489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2067EB-531C-4D1A-AD66-42236629F9B6}" type="datetimeFigureOut">
              <a:rPr lang="nl-BE" smtClean="0"/>
              <a:t>10/12/2018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33E0BE-4853-403E-9FA7-4C3BE85CD619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4218261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483125" y="1135999"/>
            <a:ext cx="1754419" cy="1324427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738045" y="921277"/>
            <a:ext cx="13099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900" i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Cre-negative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1832998" y="1136000"/>
            <a:ext cx="1754419" cy="1324427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4620214" y="1136000"/>
            <a:ext cx="1754419" cy="1324427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3278732" y="1136000"/>
            <a:ext cx="1754419" cy="1324427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2062474" y="921002"/>
            <a:ext cx="130994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900" i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Cre-positive</a:t>
            </a:r>
            <a:endParaRPr lang="nl-BE" sz="900" i="1" baseline="30000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522133" y="921002"/>
            <a:ext cx="126653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900" i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Cre-negative</a:t>
            </a:r>
            <a:endParaRPr lang="nl-BE" sz="900" i="1" baseline="30000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835210" y="921002"/>
            <a:ext cx="132442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900" i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Cre-positive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698121" y="690033"/>
            <a:ext cx="26743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900" b="1" dirty="0">
                <a:latin typeface="Arial" charset="0"/>
                <a:ea typeface="Arial" charset="0"/>
                <a:cs typeface="Arial" charset="0"/>
              </a:rPr>
              <a:t>Brainstem</a:t>
            </a:r>
            <a:endParaRPr lang="nl-BE" sz="900" b="1" baseline="30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492101" y="690033"/>
            <a:ext cx="26743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900" b="1" dirty="0">
                <a:latin typeface="Arial" charset="0"/>
                <a:ea typeface="Arial" charset="0"/>
                <a:cs typeface="Arial" charset="0"/>
              </a:rPr>
              <a:t>Motor cortex</a:t>
            </a:r>
            <a:endParaRPr lang="nl-BE" sz="900" b="1" baseline="30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708548" y="2457448"/>
            <a:ext cx="10059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1000" b="1" dirty="0">
                <a:solidFill>
                  <a:srgbClr val="68EE32"/>
                </a:solidFill>
                <a:latin typeface="Arial" pitchFamily="34" charset="0"/>
                <a:cs typeface="Arial" pitchFamily="34" charset="0"/>
              </a:rPr>
              <a:t>IBA1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5647267" y="2490118"/>
            <a:ext cx="5357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sz="8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100 µm</a:t>
            </a:r>
          </a:p>
        </p:txBody>
      </p:sp>
      <p:cxnSp>
        <p:nvCxnSpPr>
          <p:cNvPr id="28" name="Straight Connector 27"/>
          <p:cNvCxnSpPr/>
          <p:nvPr/>
        </p:nvCxnSpPr>
        <p:spPr>
          <a:xfrm>
            <a:off x="5831512" y="2517726"/>
            <a:ext cx="232356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>
            <a:off x="695379" y="920865"/>
            <a:ext cx="611000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A	            		B	                	 C	             		D</a:t>
            </a:r>
          </a:p>
        </p:txBody>
      </p:sp>
      <p:sp>
        <p:nvSpPr>
          <p:cNvPr id="32" name="TextBox 31"/>
          <p:cNvSpPr txBox="1"/>
          <p:nvPr/>
        </p:nvSpPr>
        <p:spPr>
          <a:xfrm flipH="1">
            <a:off x="695379" y="228049"/>
            <a:ext cx="26316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dditional</a:t>
            </a:r>
            <a:r>
              <a:rPr lang="nl-BE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BE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nl-BE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l-BE" i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</p:spTree>
    <p:extLst>
      <p:ext uri="{BB962C8B-B14F-4D97-AF65-F5344CB8AC3E}">
        <p14:creationId xmlns:p14="http://schemas.microsoft.com/office/powerpoint/2010/main" val="2265771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844</TotalTime>
  <Words>14</Words>
  <Application>Microsoft Office PowerPoint</Application>
  <PresentationFormat>A4 Paper (210x297 mm)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KULeuv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0004656</dc:creator>
  <cp:lastModifiedBy>u0004656</cp:lastModifiedBy>
  <cp:revision>15</cp:revision>
  <cp:lastPrinted>2018-12-10T16:03:42Z</cp:lastPrinted>
  <dcterms:created xsi:type="dcterms:W3CDTF">2018-09-11T08:23:44Z</dcterms:created>
  <dcterms:modified xsi:type="dcterms:W3CDTF">2018-12-10T21:38:38Z</dcterms:modified>
</cp:coreProperties>
</file>